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199313" cy="899953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62C31A-93E7-4ADE-8446-5BCE3013591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0360" y="360000"/>
            <a:ext cx="6480000" cy="15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0360" y="2099880"/>
            <a:ext cx="648000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0360" y="5202720"/>
            <a:ext cx="648000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65CB2D-4512-4C3D-8EBE-2FBDB6752F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0360" y="360000"/>
            <a:ext cx="6480000" cy="15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0360" y="2099880"/>
            <a:ext cx="316188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680640" y="2099880"/>
            <a:ext cx="316188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0360" y="5202720"/>
            <a:ext cx="316188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680640" y="5202720"/>
            <a:ext cx="316188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221A18-3C9D-4DD8-9491-06FC2295DE3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0360" y="360000"/>
            <a:ext cx="6480000" cy="15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0360" y="2099880"/>
            <a:ext cx="208620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51320" y="2099880"/>
            <a:ext cx="208620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742280" y="2099880"/>
            <a:ext cx="208620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0360" y="5202720"/>
            <a:ext cx="208620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51320" y="5202720"/>
            <a:ext cx="208620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742280" y="5202720"/>
            <a:ext cx="208620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BCC8BE-0BAA-4E64-B0BE-171B6D2B85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0360" y="360000"/>
            <a:ext cx="6480000" cy="15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0360" y="2099880"/>
            <a:ext cx="6480000" cy="594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97195F-567D-43A1-8AF2-DD8443E1E3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0360" y="360000"/>
            <a:ext cx="6480000" cy="15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0360" y="2099880"/>
            <a:ext cx="6480000" cy="594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226E9B-59D1-4A1F-9E1E-229B8D0CCA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0360" y="360000"/>
            <a:ext cx="6480000" cy="15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0360" y="2099880"/>
            <a:ext cx="3161880" cy="594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680640" y="2099880"/>
            <a:ext cx="3161880" cy="594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891AE5-3DF8-491F-BA6B-FC0CF41FAC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0360" y="360000"/>
            <a:ext cx="6480000" cy="15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21BA69-3460-48AA-8B7E-7803F2445D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0360" y="360000"/>
            <a:ext cx="6480000" cy="6954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20CD3F-A4A1-4893-9886-A79205DBF1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0360" y="360000"/>
            <a:ext cx="6480000" cy="15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0360" y="2099880"/>
            <a:ext cx="316188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680640" y="2099880"/>
            <a:ext cx="3161880" cy="594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0360" y="5202720"/>
            <a:ext cx="316188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3B6910-F196-4F70-8E73-D2C0A412F8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0360" y="360000"/>
            <a:ext cx="6480000" cy="15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0360" y="2099880"/>
            <a:ext cx="3161880" cy="594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680640" y="2099880"/>
            <a:ext cx="316188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680640" y="5202720"/>
            <a:ext cx="316188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CEF79D-C8C2-4C0B-9CDB-F248A7F9AC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0360" y="360000"/>
            <a:ext cx="6480000" cy="15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0360" y="2099880"/>
            <a:ext cx="316188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680640" y="2099880"/>
            <a:ext cx="316188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0360" y="5202720"/>
            <a:ext cx="6480000" cy="283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15EDD6-C9B4-4324-A95D-72F2D73C98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0360" y="360000"/>
            <a:ext cx="6480000" cy="15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0360" y="2099880"/>
            <a:ext cx="6480000" cy="594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0000" y="8196120"/>
            <a:ext cx="1679400" cy="62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60600" y="8196120"/>
            <a:ext cx="2279520" cy="62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160600" y="8196120"/>
            <a:ext cx="1679400" cy="62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F3B2AD-CD8C-4D3B-BC90-F7D371F38AA7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rcRect l="0" t="85984" r="0" b="0"/>
          <a:stretch/>
        </p:blipFill>
        <p:spPr>
          <a:xfrm>
            <a:off x="627120" y="3746520"/>
            <a:ext cx="6732360" cy="42321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"/>
          <p:cNvPicPr/>
          <p:nvPr/>
        </p:nvPicPr>
        <p:blipFill>
          <a:blip r:embed="rId2"/>
          <a:srcRect l="0" t="418" r="0" b="13917"/>
          <a:stretch/>
        </p:blipFill>
        <p:spPr>
          <a:xfrm>
            <a:off x="627120" y="39600"/>
            <a:ext cx="6732360" cy="3640320"/>
          </a:xfrm>
          <a:prstGeom prst="rect">
            <a:avLst/>
          </a:prstGeom>
          <a:ln w="0">
            <a:noFill/>
          </a:ln>
        </p:spPr>
      </p:pic>
      <p:sp>
        <p:nvSpPr>
          <p:cNvPr id="43" name="Line 6"/>
          <p:cNvSpPr/>
          <p:nvPr/>
        </p:nvSpPr>
        <p:spPr>
          <a:xfrm flipV="1">
            <a:off x="615960" y="3646080"/>
            <a:ext cx="122400" cy="71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7"/>
          <p:cNvSpPr/>
          <p:nvPr/>
        </p:nvSpPr>
        <p:spPr>
          <a:xfrm flipV="1">
            <a:off x="619200" y="3704760"/>
            <a:ext cx="122040" cy="71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28"/>
          <p:cNvSpPr/>
          <p:nvPr/>
        </p:nvSpPr>
        <p:spPr>
          <a:xfrm rot="17808000">
            <a:off x="16488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1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29"/>
          <p:cNvSpPr/>
          <p:nvPr/>
        </p:nvSpPr>
        <p:spPr>
          <a:xfrm rot="17808000">
            <a:off x="36648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409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31"/>
          <p:cNvSpPr/>
          <p:nvPr/>
        </p:nvSpPr>
        <p:spPr>
          <a:xfrm rot="17808000">
            <a:off x="55224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1102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35"/>
          <p:cNvSpPr/>
          <p:nvPr/>
        </p:nvSpPr>
        <p:spPr>
          <a:xfrm rot="17808000">
            <a:off x="94932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004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36"/>
          <p:cNvSpPr/>
          <p:nvPr/>
        </p:nvSpPr>
        <p:spPr>
          <a:xfrm rot="17808000">
            <a:off x="134604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303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38"/>
          <p:cNvSpPr/>
          <p:nvPr/>
        </p:nvSpPr>
        <p:spPr>
          <a:xfrm rot="17808000">
            <a:off x="1541160" y="781200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388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40"/>
          <p:cNvSpPr/>
          <p:nvPr/>
        </p:nvSpPr>
        <p:spPr>
          <a:xfrm rot="17808000">
            <a:off x="193356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677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41"/>
          <p:cNvSpPr/>
          <p:nvPr/>
        </p:nvSpPr>
        <p:spPr>
          <a:xfrm rot="17808000">
            <a:off x="231768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73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42"/>
          <p:cNvSpPr/>
          <p:nvPr/>
        </p:nvSpPr>
        <p:spPr>
          <a:xfrm rot="17808000">
            <a:off x="2517480" y="781200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830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43"/>
          <p:cNvSpPr/>
          <p:nvPr/>
        </p:nvSpPr>
        <p:spPr>
          <a:xfrm rot="17808000">
            <a:off x="2711160" y="781200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83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44"/>
          <p:cNvSpPr/>
          <p:nvPr/>
        </p:nvSpPr>
        <p:spPr>
          <a:xfrm rot="17808000">
            <a:off x="290664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83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46"/>
          <p:cNvSpPr/>
          <p:nvPr/>
        </p:nvSpPr>
        <p:spPr>
          <a:xfrm rot="17808000">
            <a:off x="329544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88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47"/>
          <p:cNvSpPr/>
          <p:nvPr/>
        </p:nvSpPr>
        <p:spPr>
          <a:xfrm rot="17808000">
            <a:off x="3485880" y="781200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1099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48"/>
          <p:cNvSpPr/>
          <p:nvPr/>
        </p:nvSpPr>
        <p:spPr>
          <a:xfrm rot="17808000">
            <a:off x="368604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110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49"/>
          <p:cNvSpPr/>
          <p:nvPr/>
        </p:nvSpPr>
        <p:spPr>
          <a:xfrm rot="17808000">
            <a:off x="3889080" y="781200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1198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52"/>
          <p:cNvSpPr/>
          <p:nvPr/>
        </p:nvSpPr>
        <p:spPr>
          <a:xfrm>
            <a:off x="800280" y="8728200"/>
            <a:ext cx="6271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53"/>
          <p:cNvSpPr/>
          <p:nvPr/>
        </p:nvSpPr>
        <p:spPr>
          <a:xfrm rot="16200000">
            <a:off x="-780840" y="3384360"/>
            <a:ext cx="181260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Initial fluorescence R</a:t>
            </a:r>
            <a:r>
              <a:rPr b="0" lang="de-DE" sz="1200" spc="-1" strike="noStrike" baseline="-25000">
                <a:solidFill>
                  <a:srgbClr val="000000"/>
                </a:solidFill>
                <a:latin typeface="Arial"/>
              </a:rPr>
              <a:t>0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54"/>
          <p:cNvSpPr/>
          <p:nvPr/>
        </p:nvSpPr>
        <p:spPr>
          <a:xfrm>
            <a:off x="217440" y="706428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54"/>
          <p:cNvSpPr/>
          <p:nvPr/>
        </p:nvSpPr>
        <p:spPr>
          <a:xfrm>
            <a:off x="217440" y="659304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54"/>
          <p:cNvSpPr/>
          <p:nvPr/>
        </p:nvSpPr>
        <p:spPr>
          <a:xfrm>
            <a:off x="219240" y="6105600"/>
            <a:ext cx="502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54"/>
          <p:cNvSpPr/>
          <p:nvPr/>
        </p:nvSpPr>
        <p:spPr>
          <a:xfrm>
            <a:off x="217440" y="562752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0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54"/>
          <p:cNvSpPr/>
          <p:nvPr/>
        </p:nvSpPr>
        <p:spPr>
          <a:xfrm>
            <a:off x="219240" y="5148360"/>
            <a:ext cx="502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54"/>
          <p:cNvSpPr/>
          <p:nvPr/>
        </p:nvSpPr>
        <p:spPr>
          <a:xfrm>
            <a:off x="223920" y="467820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54"/>
          <p:cNvSpPr/>
          <p:nvPr/>
        </p:nvSpPr>
        <p:spPr>
          <a:xfrm>
            <a:off x="223920" y="419724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54"/>
          <p:cNvSpPr/>
          <p:nvPr/>
        </p:nvSpPr>
        <p:spPr>
          <a:xfrm>
            <a:off x="282600" y="343368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54"/>
          <p:cNvSpPr/>
          <p:nvPr/>
        </p:nvSpPr>
        <p:spPr>
          <a:xfrm>
            <a:off x="285840" y="276876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54"/>
          <p:cNvSpPr/>
          <p:nvPr/>
        </p:nvSpPr>
        <p:spPr>
          <a:xfrm>
            <a:off x="285840" y="209232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54"/>
          <p:cNvSpPr/>
          <p:nvPr/>
        </p:nvSpPr>
        <p:spPr>
          <a:xfrm>
            <a:off x="282600" y="142560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54"/>
          <p:cNvSpPr/>
          <p:nvPr/>
        </p:nvSpPr>
        <p:spPr>
          <a:xfrm>
            <a:off x="285840" y="75240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54"/>
          <p:cNvSpPr/>
          <p:nvPr/>
        </p:nvSpPr>
        <p:spPr>
          <a:xfrm>
            <a:off x="282600" y="8244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6"/>
          <p:cNvSpPr/>
          <p:nvPr/>
        </p:nvSpPr>
        <p:spPr>
          <a:xfrm flipV="1">
            <a:off x="7072200" y="3645000"/>
            <a:ext cx="122400" cy="71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7"/>
          <p:cNvSpPr/>
          <p:nvPr/>
        </p:nvSpPr>
        <p:spPr>
          <a:xfrm flipV="1">
            <a:off x="7075440" y="3703680"/>
            <a:ext cx="122400" cy="71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36"/>
          <p:cNvSpPr/>
          <p:nvPr/>
        </p:nvSpPr>
        <p:spPr>
          <a:xfrm rot="17808000">
            <a:off x="113652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278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40"/>
          <p:cNvSpPr/>
          <p:nvPr/>
        </p:nvSpPr>
        <p:spPr>
          <a:xfrm rot="17808000">
            <a:off x="1726920" y="781200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507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40"/>
          <p:cNvSpPr/>
          <p:nvPr/>
        </p:nvSpPr>
        <p:spPr>
          <a:xfrm rot="17808000">
            <a:off x="2122200" y="781200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688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40"/>
          <p:cNvSpPr/>
          <p:nvPr/>
        </p:nvSpPr>
        <p:spPr>
          <a:xfrm rot="17808000">
            <a:off x="310356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837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49"/>
          <p:cNvSpPr/>
          <p:nvPr/>
        </p:nvSpPr>
        <p:spPr>
          <a:xfrm rot="17808000">
            <a:off x="427176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006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49"/>
          <p:cNvSpPr/>
          <p:nvPr/>
        </p:nvSpPr>
        <p:spPr>
          <a:xfrm rot="17808000">
            <a:off x="447192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129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49"/>
          <p:cNvSpPr/>
          <p:nvPr/>
        </p:nvSpPr>
        <p:spPr>
          <a:xfrm rot="17808000">
            <a:off x="4673520" y="7810560"/>
            <a:ext cx="1041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134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49"/>
          <p:cNvSpPr/>
          <p:nvPr/>
        </p:nvSpPr>
        <p:spPr>
          <a:xfrm rot="17808000">
            <a:off x="4865400" y="7810200"/>
            <a:ext cx="1041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166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49"/>
          <p:cNvSpPr/>
          <p:nvPr/>
        </p:nvSpPr>
        <p:spPr>
          <a:xfrm rot="17808000">
            <a:off x="506412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594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49"/>
          <p:cNvSpPr/>
          <p:nvPr/>
        </p:nvSpPr>
        <p:spPr>
          <a:xfrm rot="17808000">
            <a:off x="526392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632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49"/>
          <p:cNvSpPr/>
          <p:nvPr/>
        </p:nvSpPr>
        <p:spPr>
          <a:xfrm rot="17808000">
            <a:off x="545616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68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49"/>
          <p:cNvSpPr/>
          <p:nvPr/>
        </p:nvSpPr>
        <p:spPr>
          <a:xfrm rot="17808000">
            <a:off x="5655960" y="781200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933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49"/>
          <p:cNvSpPr/>
          <p:nvPr/>
        </p:nvSpPr>
        <p:spPr>
          <a:xfrm rot="17808000">
            <a:off x="585612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0934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49"/>
          <p:cNvSpPr/>
          <p:nvPr/>
        </p:nvSpPr>
        <p:spPr>
          <a:xfrm rot="17808000">
            <a:off x="603720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104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49"/>
          <p:cNvSpPr/>
          <p:nvPr/>
        </p:nvSpPr>
        <p:spPr>
          <a:xfrm rot="17808000">
            <a:off x="6237000" y="781200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109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49"/>
          <p:cNvSpPr/>
          <p:nvPr/>
        </p:nvSpPr>
        <p:spPr>
          <a:xfrm rot="17808000">
            <a:off x="6437160" y="7812360"/>
            <a:ext cx="104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GSG_1156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56"/>
          <p:cNvSpPr/>
          <p:nvPr/>
        </p:nvSpPr>
        <p:spPr>
          <a:xfrm>
            <a:off x="482760" y="8426520"/>
            <a:ext cx="43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57"/>
          <p:cNvSpPr/>
          <p:nvPr/>
        </p:nvSpPr>
        <p:spPr>
          <a:xfrm>
            <a:off x="1266840" y="8426520"/>
            <a:ext cx="298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58"/>
          <p:cNvSpPr/>
          <p:nvPr/>
        </p:nvSpPr>
        <p:spPr>
          <a:xfrm>
            <a:off x="4587840" y="8426520"/>
            <a:ext cx="2232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59"/>
          <p:cNvSpPr/>
          <p:nvPr/>
        </p:nvSpPr>
        <p:spPr>
          <a:xfrm>
            <a:off x="411120" y="8408880"/>
            <a:ext cx="576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YP5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60"/>
          <p:cNvSpPr/>
          <p:nvPr/>
        </p:nvSpPr>
        <p:spPr>
          <a:xfrm>
            <a:off x="1274760" y="8408880"/>
            <a:ext cx="2952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</a:rPr>
              <a:t>ABC transporter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61"/>
          <p:cNvSpPr/>
          <p:nvPr/>
        </p:nvSpPr>
        <p:spPr>
          <a:xfrm>
            <a:off x="4586400" y="8413920"/>
            <a:ext cx="2233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</a:rPr>
              <a:t>transcription factor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26T16:33:28Z</dcterms:created>
  <dc:creator>Rayko Becher</dc:creator>
  <dc:description/>
  <dc:language>en-US</dc:language>
  <cp:lastModifiedBy>Stefan G.R. Wirsel</cp:lastModifiedBy>
  <dcterms:modified xsi:type="dcterms:W3CDTF">2010-11-25T17:35:07Z</dcterms:modified>
  <cp:revision>6</cp:revision>
  <dc:subject/>
  <dc:title>Folie 1</dc:title>
</cp:coreProperties>
</file>